
<file path=[Content_Types].xml><?xml version="1.0" encoding="utf-8"?>
<Types xmlns="http://schemas.openxmlformats.org/package/2006/content-types">
  <Override PartName="/ppt/tags/tag1.xml" ContentType="application/vnd.openxmlformats-officedocument.presentationml.tags+xml"/>
  <Default Extension="rels" ContentType="application/vnd.openxmlformats-package.relationships+xml"/>
  <Override PartName="/ppt/slideLayouts/slideLayout1.xml" ContentType="application/vnd.openxmlformats-officedocument.presentationml.slideLayout+xml"/>
  <Default Extension="jpeg" ContentType="image/jpeg"/>
  <Default Extension="xml" ContentType="application/xml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docProps/core.xml" ContentType="application/vnd.openxmlformats-package.core-properties+xml"/>
  <Override PartName="/ppt/slideLayouts/slideLayout4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10.xml" ContentType="application/vnd.openxmlformats-officedocument.presentationml.slideLayout+xml"/>
  <Override PartName="/ppt/slides/slide3.xml" ContentType="application/vnd.openxmlformats-officedocument.presentationml.slide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slides/slide8.xml" ContentType="application/vnd.openxmlformats-officedocument.presentationml.slide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docProps/custom.xml" ContentType="application/vnd.openxmlformats-officedocument.custom-properties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5987" autoAdjust="0"/>
    <p:restoredTop sz="94660"/>
  </p:normalViewPr>
  <p:slideViewPr>
    <p:cSldViewPr snapToGrid="0">
      <p:cViewPr>
        <p:scale>
          <a:sx n="200" d="100"/>
          <a:sy n="200" d="100"/>
        </p:scale>
        <p:origin x="-88" y="1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interSettings" Target="printerSettings/printerSettings1.bin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pPr/>
              <a:t>19.10.20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pPr/>
              <a:t>‹Nr.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tags" Target="../tags/tag1.x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279848" y="1137325"/>
            <a:ext cx="8424936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cs typeface="+mn-lt"/>
                <a:sym typeface="+mn-ea"/>
              </a:rPr>
              <a:t>Table</a:t>
            </a:r>
            <a:r>
              <a:rPr lang="en-US" altLang="zh-CN" sz="1200" b="1" dirty="0" smtClean="0">
                <a:cs typeface="+mn-lt"/>
                <a:sym typeface="+mn-ea"/>
              </a:rPr>
              <a:t> S1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nce Analysis of the Quadratic Polynomial Regression Model for Time to Harvest</a:t>
            </a:r>
          </a:p>
        </p:txBody>
      </p:sp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2279576" y="1412776"/>
          <a:ext cx="6790690" cy="3794858"/>
        </p:xfrm>
        <a:graphic>
          <a:graphicData uri="http://schemas.openxmlformats.org/drawingml/2006/table">
            <a:tbl>
              <a:tblPr firstRow="1" firstCol="1" bandRow="1"/>
              <a:tblGrid>
                <a:gridCol w="1245870"/>
                <a:gridCol w="1099185"/>
                <a:gridCol w="911225"/>
                <a:gridCol w="1197610"/>
                <a:gridCol w="989965"/>
                <a:gridCol w="1346835"/>
              </a:tblGrid>
              <a:tr h="4962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ourc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um of squares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d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ean squar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P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odel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91.3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3.9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3.21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9760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inear mixture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17.12</a:t>
                      </a:r>
                      <a:endParaRPr lang="zh-CN" altLang="en-US" sz="1050" kern="100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8.56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6.8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18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10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10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01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97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18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16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16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0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94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7.00</a:t>
                      </a:r>
                      <a:endParaRPr lang="en-US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7.00</a:t>
                      </a:r>
                      <a:endParaRPr lang="en-US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6.4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00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25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25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2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630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6.5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6.5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5.7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8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8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8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776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8084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Residu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1.64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03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760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ack of fit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6.48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1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56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870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8084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Error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5.17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84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760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Tot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12.9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279581" y="1497494"/>
            <a:ext cx="8208912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cs typeface="+mn-lt"/>
                <a:sym typeface="+mn-ea"/>
              </a:rPr>
              <a:t>Table</a:t>
            </a:r>
            <a:r>
              <a:rPr lang="en-US" altLang="zh-CN" sz="1200" b="1" dirty="0" smtClean="0">
                <a:cs typeface="+mn-lt"/>
                <a:sym typeface="+mn-ea"/>
              </a:rPr>
              <a:t> S2.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nce Analysis of the Quadratic Polynomial Regression Model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p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ngth</a:t>
            </a:r>
          </a:p>
        </p:txBody>
      </p:sp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2279576" y="1772816"/>
          <a:ext cx="6699885" cy="3797935"/>
        </p:xfrm>
        <a:graphic>
          <a:graphicData uri="http://schemas.openxmlformats.org/drawingml/2006/table">
            <a:tbl>
              <a:tblPr firstRow="1" firstCol="1" bandRow="1"/>
              <a:tblGrid>
                <a:gridCol w="1228090"/>
                <a:gridCol w="1140460"/>
                <a:gridCol w="1072515"/>
                <a:gridCol w="1150620"/>
                <a:gridCol w="1249045"/>
                <a:gridCol w="859155"/>
              </a:tblGrid>
              <a:tr h="4965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ourc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um of squares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d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ean squar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P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018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ode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30.46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03.8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5.1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9814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inear mixture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72.2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6.1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7.4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18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9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93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8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3700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18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68.28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68.28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9.6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18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99.6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99.6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3.3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  <a:sym typeface="+mn-ea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891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57.2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57.2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68.4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18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5.9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5.9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9.9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00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018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r>
                        <a:rPr lang="en-US" sz="1050" kern="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6.7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6.7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1.61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02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87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Residu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8.2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30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751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ack of fit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3.2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4.40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1.03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87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Error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.0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2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814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Total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78.7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280598" y="1137072"/>
            <a:ext cx="8568952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cs typeface="+mn-lt"/>
                <a:sym typeface="+mn-ea"/>
              </a:rPr>
              <a:t>Table</a:t>
            </a:r>
            <a:r>
              <a:rPr lang="en-US" altLang="zh-CN" sz="1200" b="1" dirty="0" smtClean="0">
                <a:cs typeface="+mn-lt"/>
                <a:sym typeface="+mn-ea"/>
              </a:rPr>
              <a:t> S3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nce Analysis of the Quadratic Polynomial Regression Model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leu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ngth</a:t>
            </a:r>
          </a:p>
        </p:txBody>
      </p:sp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2280138" y="1412776"/>
          <a:ext cx="6901180" cy="4375785"/>
        </p:xfrm>
        <a:graphic>
          <a:graphicData uri="http://schemas.openxmlformats.org/drawingml/2006/table">
            <a:tbl>
              <a:tblPr firstRow="1" firstCol="1" bandRow="1"/>
              <a:tblGrid>
                <a:gridCol w="1241425"/>
                <a:gridCol w="1222375"/>
                <a:gridCol w="1007745"/>
                <a:gridCol w="1242695"/>
                <a:gridCol w="1066165"/>
                <a:gridCol w="1120775"/>
              </a:tblGrid>
              <a:tr h="57213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ourc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um of squares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d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ean squar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P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25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ode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750.2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93.7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3.9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584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inear mixture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96.3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48.1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32.64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.5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.5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.97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36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.744E-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.744E-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.142E-005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994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7.1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7.1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3.28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  <a:sym typeface="+mn-ea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300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68.4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68.4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50.80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2570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0.9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0.9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5.6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3.1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3.1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8.6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03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Residu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3.4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altLang="zh-CN" sz="1050" kern="100">
                          <a:effectLst/>
                          <a:latin typeface="Calibri" panose="020F0502020204030204"/>
                          <a:ea typeface="宋体" panose="02010600030101010101" pitchFamily="2" charset="-122"/>
                          <a:cs typeface="Times New Roman" panose="02020603050405020304"/>
                        </a:rPr>
                        <a:t>1.12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584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ack of fit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8.0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6.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9.8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03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Error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.4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30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584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Tot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773.6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280598" y="1137072"/>
            <a:ext cx="8568952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cs typeface="+mn-lt"/>
                <a:sym typeface="+mn-ea"/>
              </a:rPr>
              <a:t>Table</a:t>
            </a:r>
            <a:r>
              <a:rPr lang="en-US" altLang="zh-CN" sz="1200" b="1" dirty="0" smtClean="0">
                <a:cs typeface="+mn-lt"/>
                <a:sym typeface="+mn-ea"/>
              </a:rPr>
              <a:t> S4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nce Analysis of the Quadratic Polynomial Regression Model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leu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dth</a:t>
            </a:r>
          </a:p>
        </p:txBody>
      </p:sp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2280138" y="1412776"/>
          <a:ext cx="6901180" cy="4375785"/>
        </p:xfrm>
        <a:graphic>
          <a:graphicData uri="http://schemas.openxmlformats.org/drawingml/2006/table">
            <a:tbl>
              <a:tblPr firstRow="1" firstCol="1" bandRow="1"/>
              <a:tblGrid>
                <a:gridCol w="1241425"/>
                <a:gridCol w="1222375"/>
                <a:gridCol w="1007745"/>
                <a:gridCol w="1242695"/>
                <a:gridCol w="1066165"/>
                <a:gridCol w="1120775"/>
              </a:tblGrid>
              <a:tr h="57213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ourc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um of squares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d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ean squar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P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25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ode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708.3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8.5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04.8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584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inear mixture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36.41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68.2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0.87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3.56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3.5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6.05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00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5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5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04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95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04.7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04.7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42.4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  <a:sym typeface="+mn-ea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300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25.60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25.60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67.19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2570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93.8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93.84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11.1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193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12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12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5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128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03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Residu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7.7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altLang="zh-CN" sz="1050" kern="100">
                          <a:effectLst/>
                          <a:latin typeface="Calibri" panose="020F0502020204030204"/>
                          <a:ea typeface="宋体" panose="02010600030101010101" pitchFamily="2" charset="-122"/>
                          <a:cs typeface="Times New Roman" panose="02020603050405020304"/>
                        </a:rPr>
                        <a:t>0.84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584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ack of fit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1.2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7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0.5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003   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703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Error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6.44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36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584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Total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726.07</a:t>
                      </a:r>
                      <a:endParaRPr lang="en-US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279848" y="1137325"/>
            <a:ext cx="8424936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cs typeface="+mn-lt"/>
                <a:sym typeface="+mn-ea"/>
              </a:rPr>
              <a:t>Table</a:t>
            </a:r>
            <a:r>
              <a:rPr lang="en-US" altLang="zh-CN" sz="1200" b="1" dirty="0" smtClean="0">
                <a:cs typeface="+mn-lt"/>
                <a:sym typeface="+mn-ea"/>
              </a:rPr>
              <a:t> S5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nce Analysis of the Quadratic Polynomial Regression Model for Mycelial Growth Rate</a:t>
            </a:r>
          </a:p>
        </p:txBody>
      </p:sp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2279576" y="1412776"/>
          <a:ext cx="6790690" cy="3793885"/>
        </p:xfrm>
        <a:graphic>
          <a:graphicData uri="http://schemas.openxmlformats.org/drawingml/2006/table">
            <a:tbl>
              <a:tblPr firstRow="1" firstCol="1" bandRow="1"/>
              <a:tblGrid>
                <a:gridCol w="1245870"/>
                <a:gridCol w="1099185"/>
                <a:gridCol w="911225"/>
                <a:gridCol w="1197610"/>
                <a:gridCol w="989965"/>
                <a:gridCol w="1346835"/>
              </a:tblGrid>
              <a:tr h="49627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ourc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um of squares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d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ean squar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P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odel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4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.570E-00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84.4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9760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inear mixture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269E-00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6.343E-00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3.7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969E-00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969E-00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73.8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101E-003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101E-00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14.00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617E-003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617E-00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1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675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9.174E-00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9.174E-00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6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435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2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24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675.2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847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1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15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056.8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 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8084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Residu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043E-00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449E-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760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ack of fit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.913E-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971E-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45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2623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18084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Error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452E-004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362E-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760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Tot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4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351718" y="1183571"/>
            <a:ext cx="8424936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cs typeface="+mn-lt"/>
                <a:sym typeface="+mn-ea"/>
              </a:rPr>
              <a:t>Table</a:t>
            </a:r>
            <a:r>
              <a:rPr lang="en-US" altLang="zh-CN" sz="1200" b="1" dirty="0" smtClean="0">
                <a:cs typeface="+mn-lt"/>
                <a:sym typeface="+mn-ea"/>
              </a:rPr>
              <a:t> S6.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nce Analysis of the Quadratic Polynomial Regression Model for Yield</a:t>
            </a:r>
          </a:p>
        </p:txBody>
      </p:sp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2351584" y="1459127"/>
          <a:ext cx="7056755" cy="4302760"/>
        </p:xfrm>
        <a:graphic>
          <a:graphicData uri="http://schemas.openxmlformats.org/drawingml/2006/table">
            <a:tbl>
              <a:tblPr firstRow="1" firstCol="1" bandRow="1"/>
              <a:tblGrid>
                <a:gridCol w="1331595"/>
                <a:gridCol w="1260475"/>
                <a:gridCol w="1124585"/>
                <a:gridCol w="1302385"/>
                <a:gridCol w="1228725"/>
                <a:gridCol w="808990"/>
              </a:tblGrid>
              <a:tr h="56769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ourc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Sum of squares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d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ean square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F</a:t>
                      </a: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 P</a:t>
                      </a:r>
                    </a:p>
                    <a:p>
                      <a:pPr algn="ctr" fontAlgn="ctr">
                        <a:spcAft>
                          <a:spcPts val="0"/>
                        </a:spcAft>
                      </a:pPr>
                      <a:endParaRPr lang="en-US" sz="1200" b="1" kern="0" dirty="0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749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Mode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413E+00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.267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6.3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5021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inear mixture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.198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099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2.9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002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981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981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2.2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022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7490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698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698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0.4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040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7490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703.9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703.9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4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8370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7490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831E+00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831E+00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12.9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0.0001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0544.3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40544.3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.50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128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7490">
                <a:tc>
                  <a:txBody>
                    <a:bodyPr/>
                    <a:lstStyle/>
                    <a:p>
                      <a:pPr indent="266700"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X</a:t>
                      </a:r>
                      <a:r>
                        <a:rPr lang="en-US" sz="1050" kern="0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r>
                        <a:rPr lang="en-US" sz="1050" kern="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189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189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7.3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0.0132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0680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Residu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405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6213.62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5021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Lack of fit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400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.133E+005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840.0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&lt;0.000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004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Error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531.17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18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9.51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50215"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Total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3.754E+006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Aft>
                          <a:spcPts val="0"/>
                        </a:spcAft>
                      </a:pPr>
                      <a:r>
                        <a:rPr lang="en-US" sz="105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29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5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ea typeface="宋体" panose="02010600030101010101" pitchFamily="2" charset="-122"/>
                          <a:cs typeface="Times New Roman" panose="02020603050405020304"/>
                        </a:rPr>
                        <a:t> </a:t>
                      </a:r>
                      <a:endParaRPr lang="zh-CN" sz="1050" kern="100" dirty="0">
                        <a:effectLst/>
                        <a:latin typeface="Calibri" panose="020F0502020204030204"/>
                        <a:ea typeface="宋体" panose="02010600030101010101" pitchFamily="2" charset="-122"/>
                        <a:cs typeface="Times New Roman" panose="02020603050405020304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2390775" y="1565910"/>
          <a:ext cx="6604635" cy="1106170"/>
        </p:xfrm>
        <a:graphic>
          <a:graphicData uri="http://schemas.openxmlformats.org/drawingml/2006/table">
            <a:tbl>
              <a:tblPr/>
              <a:tblGrid>
                <a:gridCol w="1333500"/>
                <a:gridCol w="1003935"/>
                <a:gridCol w="1003935"/>
                <a:gridCol w="1003935"/>
                <a:gridCol w="1004570"/>
                <a:gridCol w="1254760"/>
              </a:tblGrid>
              <a:tr h="513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Formul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Stipe length (mm)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Stipe width (mm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Pileus length (mm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Pileus width (mm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Pileus thickness (mm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5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H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50.67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1.64</a:t>
                      </a:r>
                      <a:r>
                        <a:rPr lang="en-US" altLang="zh-CN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20.0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1.30</a:t>
                      </a:r>
                      <a:r>
                        <a:rPr lang="en-US" altLang="zh-CN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a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69.0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1.73</a:t>
                      </a:r>
                      <a:r>
                        <a:rPr lang="en-US" altLang="zh-CN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a</a:t>
                      </a:r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87.0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3.60</a:t>
                      </a:r>
                      <a:r>
                        <a:rPr lang="en-US" altLang="zh-CN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a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23.0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95</a:t>
                      </a:r>
                      <a:r>
                        <a:rPr lang="en-US" altLang="zh-CN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a</a:t>
                      </a:r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965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CK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46.0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1.73</a:t>
                      </a:r>
                      <a:r>
                        <a:rPr lang="en-US" altLang="zh-CN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b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19.0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88</a:t>
                      </a:r>
                      <a:r>
                        <a:rPr lang="en-US" altLang="zh-CN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a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68.0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3.00</a:t>
                      </a:r>
                      <a:r>
                        <a:rPr lang="en-US" altLang="zh-CN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a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66.0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2.64</a:t>
                      </a:r>
                      <a:r>
                        <a:rPr lang="en-US" altLang="zh-CN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b</a:t>
                      </a:r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20.0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2.27</a:t>
                      </a:r>
                      <a:r>
                        <a:rPr lang="en-US" altLang="zh-CN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b</a:t>
                      </a:r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2390937" y="1290017"/>
            <a:ext cx="864096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cs typeface="+mn-lt"/>
                <a:sym typeface="+mn-ea"/>
              </a:rPr>
              <a:t>Table</a:t>
            </a:r>
            <a:r>
              <a:rPr lang="en-US" altLang="zh-CN" sz="1200" b="1" dirty="0" smtClean="0">
                <a:cs typeface="+mn-lt"/>
                <a:sym typeface="+mn-ea"/>
              </a:rPr>
              <a:t> S7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Main Agronomic Traits Between the HC Formula and the CK Substrate Formula</a:t>
            </a:r>
          </a:p>
        </p:txBody>
      </p:sp>
      <p:sp>
        <p:nvSpPr>
          <p:cNvPr id="2" name="矩形 1"/>
          <p:cNvSpPr/>
          <p:nvPr/>
        </p:nvSpPr>
        <p:spPr>
          <a:xfrm>
            <a:off x="2390706" y="4144888"/>
            <a:ext cx="8208912" cy="4603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HC high yield comprehensive 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Statistical significance at a level of 5% (P &lt; 0.05) for mean values are indicated with a letter</a:t>
            </a:r>
          </a:p>
        </p:txBody>
      </p:sp>
      <p:graphicFrame>
        <p:nvGraphicFramePr>
          <p:cNvPr id="7" name="表格 6"/>
          <p:cNvGraphicFramePr>
            <a:graphicFrameLocks noGrp="1"/>
          </p:cNvGraphicFramePr>
          <p:nvPr/>
        </p:nvGraphicFramePr>
        <p:xfrm>
          <a:off x="2390775" y="2993390"/>
          <a:ext cx="6604635" cy="1127760"/>
        </p:xfrm>
        <a:graphic>
          <a:graphicData uri="http://schemas.openxmlformats.org/drawingml/2006/table">
            <a:tbl>
              <a:tblPr/>
              <a:tblGrid>
                <a:gridCol w="1333500"/>
                <a:gridCol w="1003935"/>
                <a:gridCol w="1003935"/>
                <a:gridCol w="1003935"/>
                <a:gridCol w="1004570"/>
                <a:gridCol w="1254760"/>
              </a:tblGrid>
              <a:tr h="5581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Formul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Mycelium growth rate  (mm/d)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Yield</a:t>
                      </a:r>
                    </a:p>
                    <a:p>
                      <a:pPr algn="ctr" fontAlgn="b"/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 (g/bag)</a:t>
                      </a:r>
                    </a:p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Bud forming time (d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  <a:sym typeface="+mn-ea"/>
                      </a:endParaRPr>
                    </a:p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Harvest time (d)</a:t>
                      </a:r>
                    </a:p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Reproductive stage (d)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  <a:sym typeface="+mn-ea"/>
                      </a:endParaRPr>
                    </a:p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4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H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5.56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152</a:t>
                      </a:r>
                      <a:r>
                        <a:rPr lang="en-US" altLang="zh-CN" sz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a</a:t>
                      </a:r>
                      <a:endParaRPr lang="en-US" altLang="zh-CN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82.3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70</a:t>
                      </a:r>
                      <a:r>
                        <a:rPr lang="en-US" altLang="zh-CN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a</a:t>
                      </a:r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33</a:t>
                      </a:r>
                      <a:r>
                        <a:rPr lang="en-US" altLang="zh-CN" sz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a </a:t>
                      </a:r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37</a:t>
                      </a:r>
                      <a:r>
                        <a:rPr lang="en-US" altLang="zh-CN" sz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b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4</a:t>
                      </a:r>
                      <a:r>
                        <a:rPr lang="en-US" altLang="zh-CN" sz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b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851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CK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4.94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152</a:t>
                      </a:r>
                      <a:r>
                        <a:rPr lang="en-US" altLang="zh-CN" sz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b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67.67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3.05</a:t>
                      </a:r>
                      <a:r>
                        <a:rPr lang="en-US" altLang="zh-CN" sz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b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29</a:t>
                      </a:r>
                      <a:r>
                        <a:rPr lang="en-US" altLang="zh-CN" sz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b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39</a:t>
                      </a:r>
                      <a:r>
                        <a:rPr lang="en-US" altLang="zh-CN" sz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a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10</a:t>
                      </a:r>
                      <a:r>
                        <a:rPr lang="en-US" altLang="zh-CN" sz="12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  <a:sym typeface="+mn-ea"/>
                        </a:rPr>
                        <a:t>a</a:t>
                      </a:r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2708437" y="1747217"/>
            <a:ext cx="8640960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cs typeface="+mn-lt"/>
                <a:sym typeface="+mn-ea"/>
              </a:rPr>
              <a:t>Table</a:t>
            </a:r>
            <a:r>
              <a:rPr lang="en-US" altLang="zh-CN" sz="1200" b="1" dirty="0" smtClean="0">
                <a:cs typeface="+mn-lt"/>
                <a:sym typeface="+mn-ea"/>
              </a:rPr>
              <a:t> S8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Influence of the Three Kinds of Agro-residues as 100% of the Main Ingredient on Each Evaluation Index</a:t>
            </a:r>
          </a:p>
        </p:txBody>
      </p:sp>
      <p:sp>
        <p:nvSpPr>
          <p:cNvPr id="2" name="矩形 1"/>
          <p:cNvSpPr/>
          <p:nvPr/>
        </p:nvSpPr>
        <p:spPr>
          <a:xfrm>
            <a:off x="3057456" y="3668003"/>
            <a:ext cx="8208912" cy="368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values followed by no letters are not significantly different at a level of 5% (P&lt;0.05)</a:t>
            </a:r>
          </a:p>
        </p:txBody>
      </p:sp>
      <p:graphicFrame>
        <p:nvGraphicFramePr>
          <p:cNvPr id="7" name="表格 6"/>
          <p:cNvGraphicFramePr/>
          <p:nvPr>
            <p:custDataLst>
              <p:tags r:id="rId1"/>
            </p:custDataLst>
          </p:nvPr>
        </p:nvGraphicFramePr>
        <p:xfrm>
          <a:off x="3057525" y="2023110"/>
          <a:ext cx="6717030" cy="171005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14755"/>
                <a:gridCol w="920115"/>
                <a:gridCol w="919480"/>
                <a:gridCol w="902335"/>
                <a:gridCol w="902970"/>
                <a:gridCol w="1016635"/>
                <a:gridCol w="840740"/>
              </a:tblGrid>
              <a:tr h="74358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mula</a:t>
                      </a:r>
                      <a:endParaRPr lang="en-US" altLang="en-US" sz="1200" b="1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arvest time (d)</a:t>
                      </a:r>
                      <a:endParaRPr lang="en-US" altLang="en-US" sz="1200" b="1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tipe lengh (mm)</a:t>
                      </a:r>
                      <a:endParaRPr lang="en-US" altLang="en-US" sz="1200" b="1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ileus lengh (mm)</a:t>
                      </a:r>
                      <a:endParaRPr lang="en-US" altLang="en-US" sz="1200" b="1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ileus width (mm)</a:t>
                      </a:r>
                      <a:endParaRPr lang="en-US" altLang="en-US" sz="1200" b="1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ycelial growth rate (mm/d)</a:t>
                      </a:r>
                      <a:endParaRPr lang="en-US" altLang="en-US" sz="1200" b="1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1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ield (g)</a:t>
                      </a:r>
                      <a:endParaRPr lang="en-US" altLang="en-US" sz="1200" b="1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0355"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lang="en-US" sz="1200" b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zh-CN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wheat straw</a:t>
                      </a:r>
                      <a:r>
                        <a:rPr lang="zh-CN" altLang="en-US" sz="1200" b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）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.7</a:t>
                      </a:r>
                      <a:r>
                        <a:rPr lang="zh-CN" alt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zh-CN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8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.1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70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.2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5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.2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96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87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02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061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5.5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0355"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b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altLang="zh-CN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corn straw)</a:t>
                      </a:r>
                      <a:endParaRPr lang="en-US" altLang="zh-CN" sz="12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.3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58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.2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20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8.1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65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6.9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30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76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08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22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2.6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0355"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 </a:t>
                      </a:r>
                      <a:r>
                        <a:rPr lang="en-US" sz="1200" b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zh-CN" sz="1200" b="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soybean straw)</a:t>
                      </a:r>
                      <a:endParaRPr lang="en-US" altLang="zh-CN" sz="1200" b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.0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1.00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.1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10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0.3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74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3.3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82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27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0.02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39</a:t>
                      </a:r>
                      <a:r>
                        <a:rPr lang="zh-CN" altLang="en-US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±</a:t>
                      </a:r>
                      <a:r>
                        <a:rPr lang="en-US" altLang="zh-CN" sz="12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5.5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endParaRPr lang="en-US" altLang="en-US" sz="1200" b="0"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tag name="KSO_WM_UNIT_TABLE_BEAUTIFY" val="smartTable{133c40f2-d0db-4c7b-84b2-fbb11b7cd386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:a="http://schemas.openxmlformats.org/drawingml/2006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4</Words>
  <Application>Microsoft Macintosh PowerPoint</Application>
  <PresentationFormat>Benutzerdefiniert</PresentationFormat>
  <Paragraphs>544</Paragraphs>
  <Slides>8</Slides>
  <Notes>0</Notes>
  <HiddenSlides>0</HiddenSlides>
  <MMClips>0</MMClips>
  <ScaleCrop>false</ScaleCrop>
  <HeadingPairs>
    <vt:vector size="4" baseType="variant">
      <vt:variant>
        <vt:lpstr>Entwurfsvorlage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9" baseType="lpstr">
      <vt:lpstr>Office 主题</vt:lpstr>
      <vt:lpstr>Folie 1</vt:lpstr>
      <vt:lpstr>Folie 2</vt:lpstr>
      <vt:lpstr>Folie 3</vt:lpstr>
      <vt:lpstr>Folie 4</vt:lpstr>
      <vt:lpstr>Folie 5</vt:lpstr>
      <vt:lpstr>Folie 6</vt:lpstr>
      <vt:lpstr>Folie 7</vt:lpstr>
      <vt:lpstr>Folie 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/>
  <cp:lastModifiedBy>xxx</cp:lastModifiedBy>
  <cp:revision>3</cp:revision>
  <dcterms:created xsi:type="dcterms:W3CDTF">2019-10-19T13:04:44Z</dcterms:created>
  <dcterms:modified xsi:type="dcterms:W3CDTF">2019-10-19T13:07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098</vt:lpwstr>
  </property>
</Properties>
</file>